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981" y="-17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umon\Desktop\Aurore%20Sauv\Th&#232;se\2019.08%20CRISPR%20NRP\2019.09.25%20ELISA%20NT%20786O%20RENCA%20CRISPR\Mix%20ex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umon\Desktop\Aurore%20Sauv\Th&#232;se\2019.08%20CRISPR%20NRP\2019.09.25%20ELISA%20NT%20786O%20RENCA%20CRISPR\Mix%20ex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umon\Desktop\Aurore%20Sauv\Th&#232;se\2019.08%20CRISPR%20NRP\2019.09.25%20ELISA%20NT%20786O%20RENCA%20CRISPR\Mix%20exp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umon\Desktop\Aurore%20Sauv\Th&#232;se\2019.08%20CRISPR%20NRP\2019.09.25%20ELISA%20NT%20786O%20RENCA%20CRISPR\Mix%20exp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umon\Desktop\Aurore%20Sauv\Th&#232;se\2019.08%20CRISPR%20NRP\2019.08.24%20MTT%20308%20Sun%20CRISPR%20RENCA\Exp%201%20et%202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479675411276084"/>
          <c:y val="2.4141986630236464E-2"/>
          <c:w val="0.77997323534514895"/>
          <c:h val="0.880538430146834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VGEFA!$K$1</c:f>
              <c:strCache>
                <c:ptCount val="1"/>
                <c:pt idx="0">
                  <c:v>VEGFA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FF4-492B-A0E5-45E88642187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FF4-492B-A0E5-45E886421872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4FF4-492B-A0E5-45E886421872}"/>
                </c:ext>
              </c:extLst>
            </c:dLbl>
            <c:dLbl>
              <c:idx val="1"/>
              <c:layout>
                <c:manualLayout>
                  <c:x val="-1.8286890300990705E-3"/>
                  <c:y val="-5.084170857263275E-3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2000" b="1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/>
                      <a:t>***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2000" b="1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fr-F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411133500884422"/>
                      <c:h val="0.12098040396431962"/>
                    </c:manualLayout>
                  </c15:layout>
                  <c15:showDataLabelsRange val="0"/>
                </c:ext>
                <c:ext xmlns:c16="http://schemas.microsoft.com/office/drawing/2014/chart" uri="{C3380CC4-5D6E-409C-BE32-E72D297353CC}">
                  <c16:uniqueId val="{00000003-4FF4-492B-A0E5-45E88642187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(VGEFA!$L$8,VGEFA!$L$11:$L$12)</c:f>
                <c:numCache>
                  <c:formatCode>General</c:formatCode>
                  <c:ptCount val="2"/>
                  <c:pt idx="0">
                    <c:v>14.732768254883903</c:v>
                  </c:pt>
                  <c:pt idx="1">
                    <c:v>5.41781675182421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VGEFA!$I$2,VGEFA!$I$5:$I$6)</c:f>
              <c:strCache>
                <c:ptCount val="2"/>
                <c:pt idx="0">
                  <c:v>RENCA</c:v>
                </c:pt>
                <c:pt idx="1">
                  <c:v>5.1 8</c:v>
                </c:pt>
              </c:strCache>
            </c:strRef>
          </c:cat>
          <c:val>
            <c:numRef>
              <c:f>(VGEFA!$K$2,VGEFA!$K$5:$K$6)</c:f>
              <c:numCache>
                <c:formatCode>General</c:formatCode>
                <c:ptCount val="2"/>
                <c:pt idx="0">
                  <c:v>100</c:v>
                </c:pt>
                <c:pt idx="1">
                  <c:v>33.906431867360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FF4-492B-A0E5-45E88642187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730556863"/>
        <c:axId val="541396655"/>
      </c:barChart>
      <c:catAx>
        <c:axId val="73055686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541396655"/>
        <c:crosses val="autoZero"/>
        <c:auto val="1"/>
        <c:lblAlgn val="ctr"/>
        <c:lblOffset val="100"/>
        <c:noMultiLvlLbl val="0"/>
      </c:catAx>
      <c:valAx>
        <c:axId val="54139665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7305568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093723820141981"/>
          <c:y val="2.7577158393570129E-2"/>
          <c:w val="0.77270085373179109"/>
          <c:h val="0.87539785334285503"/>
        </c:manualLayout>
      </c:layout>
      <c:barChart>
        <c:barDir val="col"/>
        <c:grouping val="clustered"/>
        <c:varyColors val="0"/>
        <c:ser>
          <c:idx val="0"/>
          <c:order val="0"/>
          <c:tx>
            <c:v>VEGFC</c:v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52A-4A81-B076-A407E1E2821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52A-4A81-B076-A407E1E2821B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52A-4A81-B076-A407E1E2821B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2000" b="1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/>
                      <a:t>***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2000" b="1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fr-F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586786139871376"/>
                      <c:h val="0.1123390994160204"/>
                    </c:manualLayout>
                  </c15:layout>
                  <c15:showDataLabelsRange val="0"/>
                </c:ext>
                <c:ext xmlns:c16="http://schemas.microsoft.com/office/drawing/2014/chart" uri="{C3380CC4-5D6E-409C-BE32-E72D297353CC}">
                  <c16:uniqueId val="{00000003-B52A-4A81-B076-A407E1E2821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(VEGFC!$L$8,VEGFC!$L$11:$L$12)</c:f>
                <c:numCache>
                  <c:formatCode>General</c:formatCode>
                  <c:ptCount val="2"/>
                  <c:pt idx="0">
                    <c:v>10.058714760752958</c:v>
                  </c:pt>
                  <c:pt idx="1">
                    <c:v>2.60361404755982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VEGFC!$I$2,VEGFC!$I$5:$I$6)</c:f>
              <c:strCache>
                <c:ptCount val="2"/>
                <c:pt idx="0">
                  <c:v>RENCA</c:v>
                </c:pt>
                <c:pt idx="1">
                  <c:v>5.1 8</c:v>
                </c:pt>
              </c:strCache>
            </c:strRef>
          </c:cat>
          <c:val>
            <c:numRef>
              <c:f>(VEGFC!$K$2,VEGFC!$K$5:$K$6)</c:f>
              <c:numCache>
                <c:formatCode>General</c:formatCode>
                <c:ptCount val="2"/>
                <c:pt idx="0">
                  <c:v>100</c:v>
                </c:pt>
                <c:pt idx="1">
                  <c:v>40.075925802984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52A-4A81-B076-A407E1E2821B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743221663"/>
        <c:axId val="541401231"/>
      </c:barChart>
      <c:catAx>
        <c:axId val="74322166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541401231"/>
        <c:crosses val="autoZero"/>
        <c:auto val="1"/>
        <c:lblAlgn val="ctr"/>
        <c:lblOffset val="100"/>
        <c:noMultiLvlLbl val="0"/>
      </c:catAx>
      <c:valAx>
        <c:axId val="54140123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7432216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043238225183605"/>
          <c:y val="1.9956757960281617E-2"/>
          <c:w val="0.78956761774816397"/>
          <c:h val="0.8888784651014723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CB2-4A4E-AA79-5C94546909FE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  <a:alpha val="98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CB2-4A4E-AA79-5C94546909FE}"/>
              </c:ext>
            </c:extLst>
          </c:dPt>
          <c:errBars>
            <c:errBarType val="plus"/>
            <c:errValType val="cust"/>
            <c:noEndCap val="0"/>
            <c:plus>
              <c:numRef>
                <c:f>'[Mix exp.xlsx]VEGFC'!$L$8:$L$10</c:f>
                <c:numCache>
                  <c:formatCode>General</c:formatCode>
                  <c:ptCount val="3"/>
                  <c:pt idx="0">
                    <c:v>10.058714760752958</c:v>
                  </c:pt>
                  <c:pt idx="1">
                    <c:v>6.4437675376066359</c:v>
                  </c:pt>
                  <c:pt idx="2">
                    <c:v>8.2574640723412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Mix exp.xlsx]VEGFC'!$I$2,'[Mix exp.xlsx]VEGFC'!$I$3</c:f>
              <c:strCache>
                <c:ptCount val="2"/>
                <c:pt idx="0">
                  <c:v>RENCA</c:v>
                </c:pt>
                <c:pt idx="1">
                  <c:v>4.1 7</c:v>
                </c:pt>
              </c:strCache>
            </c:strRef>
          </c:cat>
          <c:val>
            <c:numRef>
              <c:f>'[Mix exp.xlsx]VEGFC'!$K$2:$K$3</c:f>
              <c:numCache>
                <c:formatCode>General</c:formatCode>
                <c:ptCount val="2"/>
                <c:pt idx="0">
                  <c:v>100</c:v>
                </c:pt>
                <c:pt idx="1">
                  <c:v>86.9511458664545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CB2-4A4E-AA79-5C94546909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0560463"/>
        <c:axId val="530992495"/>
      </c:barChart>
      <c:catAx>
        <c:axId val="73056046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530992495"/>
        <c:crosses val="autoZero"/>
        <c:auto val="1"/>
        <c:lblAlgn val="ctr"/>
        <c:lblOffset val="100"/>
        <c:noMultiLvlLbl val="0"/>
      </c:catAx>
      <c:valAx>
        <c:axId val="53099249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7305604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169925925513523"/>
          <c:y val="3.3413782408273619E-2"/>
          <c:w val="0.70830074074486471"/>
          <c:h val="0.886889835414252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ix exp.xlsx]VGEFA'!$K$1</c:f>
              <c:strCache>
                <c:ptCount val="1"/>
                <c:pt idx="0">
                  <c:v>VEGFA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30A-4051-849A-A71E3207C87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30A-4051-849A-A71E3207C87F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30A-4051-849A-A71E3207C87F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*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1614885046752386"/>
                      <c:h val="0.10358429528864777"/>
                    </c:manualLayout>
                  </c15:layout>
                  <c15:showDataLabelsRange val="0"/>
                </c:ext>
                <c:ext xmlns:c16="http://schemas.microsoft.com/office/drawing/2014/chart" uri="{C3380CC4-5D6E-409C-BE32-E72D297353CC}">
                  <c16:uniqueId val="{00000003-E30A-4051-849A-A71E3207C87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'[Mix exp.xlsx]VGEFA'!$L$8:$L$10</c:f>
                <c:numCache>
                  <c:formatCode>General</c:formatCode>
                  <c:ptCount val="3"/>
                  <c:pt idx="0">
                    <c:v>14.732768254883903</c:v>
                  </c:pt>
                  <c:pt idx="1">
                    <c:v>1.2140146116761339</c:v>
                  </c:pt>
                  <c:pt idx="2">
                    <c:v>4.79750163035975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Mix exp.xlsx]VGEFA'!$I$2:$I$3</c:f>
              <c:strCache>
                <c:ptCount val="2"/>
                <c:pt idx="0">
                  <c:v>RENCA</c:v>
                </c:pt>
                <c:pt idx="1">
                  <c:v>4.1 7</c:v>
                </c:pt>
              </c:strCache>
            </c:strRef>
          </c:cat>
          <c:val>
            <c:numRef>
              <c:f>'[Mix exp.xlsx]VGEFA'!$K$2:$K$3</c:f>
              <c:numCache>
                <c:formatCode>General</c:formatCode>
                <c:ptCount val="2"/>
                <c:pt idx="0">
                  <c:v>100</c:v>
                </c:pt>
                <c:pt idx="1">
                  <c:v>32.4818389898211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30A-4051-849A-A71E3207C87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681528687"/>
        <c:axId val="541393327"/>
      </c:barChart>
      <c:catAx>
        <c:axId val="68152868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541393327"/>
        <c:crosses val="autoZero"/>
        <c:auto val="1"/>
        <c:lblAlgn val="ctr"/>
        <c:lblOffset val="100"/>
        <c:noMultiLvlLbl val="0"/>
      </c:catAx>
      <c:valAx>
        <c:axId val="54139332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6815286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1998173887142878"/>
          <c:y val="3.0062529382780253E-2"/>
          <c:w val="0.68001826112857111"/>
          <c:h val="0.86835383886318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G$1</c:f>
              <c:strCache>
                <c:ptCount val="1"/>
                <c:pt idx="0">
                  <c:v>NRP1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E66-4D8C-8FBD-DB4710AF28F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E66-4D8C-8FBD-DB4710AF28F5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DE66-4D8C-8FBD-DB4710AF28F5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*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4443133008381746"/>
                      <c:h val="0.17055793933777857"/>
                    </c:manualLayout>
                  </c15:layout>
                  <c15:showDataLabelsRange val="0"/>
                </c:ext>
                <c:ext xmlns:c16="http://schemas.microsoft.com/office/drawing/2014/chart" uri="{C3380CC4-5D6E-409C-BE32-E72D297353CC}">
                  <c16:uniqueId val="{00000003-DE66-4D8C-8FBD-DB4710AF28F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Feuil1!$G$6:$G$7</c:f>
                <c:numCache>
                  <c:formatCode>General</c:formatCode>
                  <c:ptCount val="2"/>
                  <c:pt idx="0">
                    <c:v>2.4999999999999471E-2</c:v>
                  </c:pt>
                  <c:pt idx="1">
                    <c:v>2.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euil1!$F$2:$F$3</c:f>
              <c:strCache>
                <c:ptCount val="2"/>
                <c:pt idx="0">
                  <c:v>RENCA</c:v>
                </c:pt>
                <c:pt idx="1">
                  <c:v>4.1 7</c:v>
                </c:pt>
              </c:strCache>
            </c:strRef>
          </c:cat>
          <c:val>
            <c:numRef>
              <c:f>Feuil1!$G$2:$G$3</c:f>
              <c:numCache>
                <c:formatCode>General</c:formatCode>
                <c:ptCount val="2"/>
                <c:pt idx="0">
                  <c:v>100</c:v>
                </c:pt>
                <c:pt idx="1">
                  <c:v>3.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E66-4D8C-8FBD-DB4710AF28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54990335"/>
        <c:axId val="1411836943"/>
      </c:barChart>
      <c:catAx>
        <c:axId val="165499033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411836943"/>
        <c:crosses val="autoZero"/>
        <c:auto val="1"/>
        <c:lblAlgn val="ctr"/>
        <c:lblOffset val="100"/>
        <c:noMultiLvlLbl val="0"/>
      </c:catAx>
      <c:valAx>
        <c:axId val="141183694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6549903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56885493159913"/>
          <c:y val="3.0083956762974172E-2"/>
          <c:w val="0.7511679567696542"/>
          <c:h val="0.8494858909211585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327-47F1-B51A-E7F55CA8EBA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327-47F1-B51A-E7F55CA8EBA8}"/>
              </c:ext>
            </c:extLst>
          </c:dPt>
          <c:errBars>
            <c:errBarType val="plus"/>
            <c:errValType val="cust"/>
            <c:noEndCap val="0"/>
            <c:plus>
              <c:numRef>
                <c:f>(Feuil1!$G$6,Feuil1!$G$8)</c:f>
                <c:numCache>
                  <c:formatCode>General</c:formatCode>
                  <c:ptCount val="2"/>
                  <c:pt idx="0">
                    <c:v>2.4999999999999471E-2</c:v>
                  </c:pt>
                  <c:pt idx="1">
                    <c:v>12.6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Feuil1!$F$2,Feuil1!$F$4)</c:f>
              <c:strCache>
                <c:ptCount val="2"/>
                <c:pt idx="0">
                  <c:v>RENCA</c:v>
                </c:pt>
                <c:pt idx="1">
                  <c:v>5.1 8</c:v>
                </c:pt>
              </c:strCache>
            </c:strRef>
          </c:cat>
          <c:val>
            <c:numRef>
              <c:f>(Feuil1!$G$2,Feuil1!$G$4)</c:f>
              <c:numCache>
                <c:formatCode>General</c:formatCode>
                <c:ptCount val="2"/>
                <c:pt idx="0">
                  <c:v>100</c:v>
                </c:pt>
                <c:pt idx="1">
                  <c:v>14.084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327-47F1-B51A-E7F55CA8EB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6544591"/>
        <c:axId val="1411820303"/>
      </c:barChart>
      <c:catAx>
        <c:axId val="15665445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411820303"/>
        <c:crosses val="autoZero"/>
        <c:auto val="1"/>
        <c:lblAlgn val="ctr"/>
        <c:lblOffset val="100"/>
        <c:noMultiLvlLbl val="0"/>
      </c:catAx>
      <c:valAx>
        <c:axId val="141182030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5665445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300835223303912"/>
          <c:y val="3.0098386417477044E-2"/>
          <c:w val="0.77464630131731971"/>
          <c:h val="0.8747831064164477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FEE-44C7-A70F-CB12F236748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FEE-44C7-A70F-CB12F2367483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AFEE-44C7-A70F-CB12F2367483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2000" b="1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/>
                      <a:t>***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2000" b="1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fr-F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728667085421977"/>
                      <c:h val="0.14233422525712022"/>
                    </c:manualLayout>
                  </c15:layout>
                  <c15:showDataLabelsRange val="0"/>
                </c:ext>
                <c:ext xmlns:c16="http://schemas.microsoft.com/office/drawing/2014/chart" uri="{C3380CC4-5D6E-409C-BE32-E72D297353CC}">
                  <c16:uniqueId val="{00000003-AFEE-44C7-A70F-CB12F236748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Feuil1!$H$6:$H$7</c:f>
                <c:numCache>
                  <c:formatCode>General</c:formatCode>
                  <c:ptCount val="2"/>
                  <c:pt idx="0">
                    <c:v>2.4999999999999471E-2</c:v>
                  </c:pt>
                  <c:pt idx="1">
                    <c:v>1.425000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euil1!$F$2:$F$3</c:f>
              <c:strCache>
                <c:ptCount val="2"/>
                <c:pt idx="0">
                  <c:v>RENCA</c:v>
                </c:pt>
                <c:pt idx="1">
                  <c:v>4.1 7</c:v>
                </c:pt>
              </c:strCache>
            </c:strRef>
          </c:cat>
          <c:val>
            <c:numRef>
              <c:f>Feuil1!$H$2:$H$3</c:f>
              <c:numCache>
                <c:formatCode>General</c:formatCode>
                <c:ptCount val="2"/>
                <c:pt idx="0">
                  <c:v>100</c:v>
                </c:pt>
                <c:pt idx="1">
                  <c:v>4.0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FEE-44C7-A70F-CB12F2367483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566571391"/>
        <c:axId val="1411813231"/>
      </c:barChart>
      <c:catAx>
        <c:axId val="15665713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411813231"/>
        <c:crosses val="autoZero"/>
        <c:auto val="1"/>
        <c:lblAlgn val="ctr"/>
        <c:lblOffset val="100"/>
        <c:noMultiLvlLbl val="0"/>
      </c:catAx>
      <c:valAx>
        <c:axId val="141181323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5665713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685198646273534"/>
          <c:y val="6.2695981039514626E-2"/>
          <c:w val="0.78582714566278933"/>
          <c:h val="0.83666346037324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6F1-4C8A-8287-034E6E88110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6F1-4C8A-8287-034E6E881105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D6F1-4C8A-8287-034E6E881105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2000" b="1" i="0" u="none" strike="noStrike" kern="1200" baseline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/>
                      <a:t>***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2000" b="1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fr-F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23658739185147"/>
                      <c:h val="0.1058076829859428"/>
                    </c:manualLayout>
                  </c15:layout>
                  <c15:showDataLabelsRange val="0"/>
                </c:ext>
                <c:ext xmlns:c16="http://schemas.microsoft.com/office/drawing/2014/chart" uri="{C3380CC4-5D6E-409C-BE32-E72D297353CC}">
                  <c16:uniqueId val="{00000003-D6F1-4C8A-8287-034E6E88110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(Feuil1!$H$6,Feuil1!$H$8)</c:f>
                <c:numCache>
                  <c:formatCode>General</c:formatCode>
                  <c:ptCount val="2"/>
                  <c:pt idx="0">
                    <c:v>2.4999999999999471E-2</c:v>
                  </c:pt>
                  <c:pt idx="1">
                    <c:v>0.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Feuil1!$F$2,Feuil1!$F$4)</c:f>
              <c:strCache>
                <c:ptCount val="2"/>
                <c:pt idx="0">
                  <c:v>RENCA</c:v>
                </c:pt>
                <c:pt idx="1">
                  <c:v>5.1 8</c:v>
                </c:pt>
              </c:strCache>
            </c:strRef>
          </c:cat>
          <c:val>
            <c:numRef>
              <c:f>(Feuil1!$H$2,Feuil1!$H$4)</c:f>
              <c:numCache>
                <c:formatCode>General</c:formatCode>
                <c:ptCount val="2"/>
                <c:pt idx="0">
                  <c:v>100</c:v>
                </c:pt>
                <c:pt idx="1">
                  <c:v>3.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6F1-4C8A-8287-034E6E8811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6563391"/>
        <c:axId val="1411844431"/>
      </c:barChart>
      <c:catAx>
        <c:axId val="15665633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411844431"/>
        <c:crosses val="autoZero"/>
        <c:auto val="1"/>
        <c:lblAlgn val="ctr"/>
        <c:lblOffset val="100"/>
        <c:noMultiLvlLbl val="0"/>
      </c:catAx>
      <c:valAx>
        <c:axId val="141184443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5665633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6964113782129588E-2"/>
          <c:y val="2.5152504404107427E-2"/>
          <c:w val="0.87565240292807722"/>
          <c:h val="0.833971352920534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Feuil1!$C$1</c:f>
              <c:strCache>
                <c:ptCount val="1"/>
                <c:pt idx="0">
                  <c:v>RENCA Ctrl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C$14:$G$14</c:f>
                <c:numCache>
                  <c:formatCode>General</c:formatCode>
                  <c:ptCount val="4"/>
                  <c:pt idx="0">
                    <c:v>7.4945213442368814</c:v>
                  </c:pt>
                  <c:pt idx="1">
                    <c:v>5.5007021376189744</c:v>
                  </c:pt>
                  <c:pt idx="2">
                    <c:v>3.8289904821345022</c:v>
                  </c:pt>
                  <c:pt idx="3">
                    <c:v>4.8715868310188775</c:v>
                  </c:pt>
                </c:numCache>
              </c:numRef>
            </c:plus>
            <c:minus>
              <c:numRef>
                <c:f>Feuil1!$C$14:$G$14</c:f>
                <c:numCache>
                  <c:formatCode>General</c:formatCode>
                  <c:ptCount val="4"/>
                  <c:pt idx="0">
                    <c:v>7.4945213442368814</c:v>
                  </c:pt>
                  <c:pt idx="1">
                    <c:v>5.5007021376189744</c:v>
                  </c:pt>
                  <c:pt idx="2">
                    <c:v>3.8289904821345022</c:v>
                  </c:pt>
                  <c:pt idx="3">
                    <c:v>4.871586831018877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Feuil1!$U$2:$Y$2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xVal>
          <c:yVal>
            <c:numRef>
              <c:f>Feuil1!$C$3:$G$3</c:f>
              <c:numCache>
                <c:formatCode>General</c:formatCode>
                <c:ptCount val="4"/>
                <c:pt idx="0">
                  <c:v>100</c:v>
                </c:pt>
                <c:pt idx="1">
                  <c:v>130.25651427679827</c:v>
                </c:pt>
                <c:pt idx="2">
                  <c:v>193.78686222499613</c:v>
                </c:pt>
                <c:pt idx="3">
                  <c:v>229.686690591355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248-41FF-A573-54EBA73F8593}"/>
            </c:ext>
          </c:extLst>
        </c:ser>
        <c:ser>
          <c:idx val="1"/>
          <c:order val="1"/>
          <c:tx>
            <c:strRef>
              <c:f>Feuil1!$I$1</c:f>
              <c:strCache>
                <c:ptCount val="1"/>
                <c:pt idx="0">
                  <c:v>RENCA 4.1 cl7</c:v>
                </c:pt>
              </c:strCache>
            </c:strRef>
          </c:tx>
          <c:spPr>
            <a:ln w="1270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12700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I$14:$M$14</c:f>
                <c:numCache>
                  <c:formatCode>General</c:formatCode>
                  <c:ptCount val="4"/>
                  <c:pt idx="0">
                    <c:v>7.0521993327930579</c:v>
                  </c:pt>
                  <c:pt idx="1">
                    <c:v>7.6747842241981639</c:v>
                  </c:pt>
                  <c:pt idx="2">
                    <c:v>8.2441871969253668</c:v>
                  </c:pt>
                  <c:pt idx="3">
                    <c:v>8.8411942098710714</c:v>
                  </c:pt>
                </c:numCache>
              </c:numRef>
            </c:plus>
            <c:minus>
              <c:numRef>
                <c:f>Feuil1!$I$14:$M$14</c:f>
                <c:numCache>
                  <c:formatCode>General</c:formatCode>
                  <c:ptCount val="4"/>
                  <c:pt idx="0">
                    <c:v>7.0521993327930579</c:v>
                  </c:pt>
                  <c:pt idx="1">
                    <c:v>7.6747842241981639</c:v>
                  </c:pt>
                  <c:pt idx="2">
                    <c:v>8.2441871969253668</c:v>
                  </c:pt>
                  <c:pt idx="3">
                    <c:v>8.841194209871071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bg1">
                    <a:lumMod val="50000"/>
                  </a:schemeClr>
                </a:solidFill>
                <a:round/>
              </a:ln>
              <a:effectLst/>
            </c:spPr>
          </c:errBars>
          <c:xVal>
            <c:numRef>
              <c:f>Feuil1!$U$2:$Y$2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xVal>
          <c:yVal>
            <c:numRef>
              <c:f>Feuil1!$I$3:$M$3</c:f>
              <c:numCache>
                <c:formatCode>General</c:formatCode>
                <c:ptCount val="4"/>
                <c:pt idx="0">
                  <c:v>100</c:v>
                </c:pt>
                <c:pt idx="1">
                  <c:v>112.87555423341301</c:v>
                </c:pt>
                <c:pt idx="2">
                  <c:v>173.23986678475904</c:v>
                </c:pt>
                <c:pt idx="3">
                  <c:v>200.0779328744027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248-41FF-A573-54EBA73F8593}"/>
            </c:ext>
          </c:extLst>
        </c:ser>
        <c:ser>
          <c:idx val="4"/>
          <c:order val="2"/>
          <c:tx>
            <c:strRef>
              <c:f>Feuil1!$AA$1</c:f>
              <c:strCache>
                <c:ptCount val="1"/>
                <c:pt idx="0">
                  <c:v>RENCA 5.1 cl8</c:v>
                </c:pt>
              </c:strCache>
            </c:strRef>
          </c:tx>
          <c:spPr>
            <a:ln w="1270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AA$14:$AE$14</c:f>
                <c:numCache>
                  <c:formatCode>General</c:formatCode>
                  <c:ptCount val="4"/>
                  <c:pt idx="0">
                    <c:v>6.6579481521596779</c:v>
                  </c:pt>
                  <c:pt idx="1">
                    <c:v>2.3004677160109424</c:v>
                  </c:pt>
                  <c:pt idx="2">
                    <c:v>6.3682937777842117</c:v>
                  </c:pt>
                  <c:pt idx="3">
                    <c:v>9.8428879653629515</c:v>
                  </c:pt>
                </c:numCache>
              </c:numRef>
            </c:plus>
            <c:minus>
              <c:numRef>
                <c:f>Feuil1!$AA$14:$AE$14</c:f>
                <c:numCache>
                  <c:formatCode>General</c:formatCode>
                  <c:ptCount val="4"/>
                  <c:pt idx="0">
                    <c:v>6.6579481521596779</c:v>
                  </c:pt>
                  <c:pt idx="1">
                    <c:v>2.3004677160109424</c:v>
                  </c:pt>
                  <c:pt idx="2">
                    <c:v>6.3682937777842117</c:v>
                  </c:pt>
                  <c:pt idx="3">
                    <c:v>9.842887965362951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bg1">
                    <a:lumMod val="85000"/>
                  </a:schemeClr>
                </a:solidFill>
                <a:round/>
              </a:ln>
              <a:effectLst/>
            </c:spPr>
          </c:errBars>
          <c:xVal>
            <c:numRef>
              <c:f>Feuil1!$U$2:$Y$2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xVal>
          <c:yVal>
            <c:numRef>
              <c:f>Feuil1!$AA$3:$AE$3</c:f>
              <c:numCache>
                <c:formatCode>General</c:formatCode>
                <c:ptCount val="4"/>
                <c:pt idx="0">
                  <c:v>100</c:v>
                </c:pt>
                <c:pt idx="1">
                  <c:v>140.54399860988428</c:v>
                </c:pt>
                <c:pt idx="2">
                  <c:v>155.47123474130817</c:v>
                </c:pt>
                <c:pt idx="3">
                  <c:v>162.6296355290403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7248-41FF-A573-54EBA73F85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8494432"/>
        <c:axId val="1909900256"/>
      </c:scatterChart>
      <c:valAx>
        <c:axId val="1998494432"/>
        <c:scaling>
          <c:orientation val="minMax"/>
          <c:max val="72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/>
                  <a:t>Time (h)</a:t>
                </a:r>
              </a:p>
            </c:rich>
          </c:tx>
          <c:layout>
            <c:manualLayout>
              <c:xMode val="edge"/>
              <c:yMode val="edge"/>
              <c:x val="0.48162226331529812"/>
              <c:y val="0.921222303746947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909900256"/>
        <c:crosses val="autoZero"/>
        <c:crossBetween val="midCat"/>
        <c:majorUnit val="24"/>
      </c:valAx>
      <c:valAx>
        <c:axId val="1909900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99849443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2584877675624897"/>
          <c:y val="0.47508143611119974"/>
          <c:w val="0.37060319489605148"/>
          <c:h val="0.311463085250050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1465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51422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4860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486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383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2126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7980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0530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7005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3457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7973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A42E5-E2FC-4C09-9616-B772EB689BC0}" type="datetimeFigureOut">
              <a:rPr lang="en-GB" smtClean="0"/>
              <a:t>10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4BF7B5-F0F5-4914-A77C-8D59B919EC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518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2E6F72B6-DBDF-4116-93CC-A0B8A91794EB}"/>
              </a:ext>
            </a:extLst>
          </p:cNvPr>
          <p:cNvSpPr txBox="1"/>
          <p:nvPr/>
        </p:nvSpPr>
        <p:spPr>
          <a:xfrm>
            <a:off x="2091483" y="11529794"/>
            <a:ext cx="27417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>
                <a:latin typeface="Arial" pitchFamily="34" charset="0"/>
                <a:cs typeface="Arial" pitchFamily="34" charset="0"/>
              </a:rPr>
              <a:t>Fig. S2: Dumond </a:t>
            </a:r>
            <a:r>
              <a:rPr lang="fr-FR" b="1" i="1" dirty="0">
                <a:latin typeface="Arial" pitchFamily="34" charset="0"/>
                <a:cs typeface="Arial" pitchFamily="34" charset="0"/>
              </a:rPr>
              <a:t>et al</a:t>
            </a:r>
            <a:endParaRPr lang="fr-FR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D3D9856-2D93-4E33-B55F-AB731A492F9A}"/>
              </a:ext>
            </a:extLst>
          </p:cNvPr>
          <p:cNvSpPr txBox="1"/>
          <p:nvPr/>
        </p:nvSpPr>
        <p:spPr>
          <a:xfrm>
            <a:off x="-6411" y="93978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74E8888D-77F4-4EDF-9DB3-91B0234B9E09}"/>
              </a:ext>
            </a:extLst>
          </p:cNvPr>
          <p:cNvSpPr txBox="1"/>
          <p:nvPr/>
        </p:nvSpPr>
        <p:spPr>
          <a:xfrm>
            <a:off x="-6411" y="4204506"/>
            <a:ext cx="351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07AB4771-0438-48EA-841B-535AE9316DA5}"/>
              </a:ext>
            </a:extLst>
          </p:cNvPr>
          <p:cNvCxnSpPr>
            <a:cxnSpLocks/>
          </p:cNvCxnSpPr>
          <p:nvPr/>
        </p:nvCxnSpPr>
        <p:spPr>
          <a:xfrm>
            <a:off x="713842" y="3797937"/>
            <a:ext cx="283886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>
            <a:extLst>
              <a:ext uri="{FF2B5EF4-FFF2-40B4-BE49-F238E27FC236}">
                <a16:creationId xmlns:a16="http://schemas.microsoft.com/office/drawing/2014/main" id="{1282327F-4491-417F-A2C3-C117ED1A6EE3}"/>
              </a:ext>
            </a:extLst>
          </p:cNvPr>
          <p:cNvSpPr txBox="1"/>
          <p:nvPr/>
        </p:nvSpPr>
        <p:spPr>
          <a:xfrm>
            <a:off x="1699501" y="3801414"/>
            <a:ext cx="982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NRP1 KO</a:t>
            </a:r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id="{537A99E3-D59C-4501-82C1-D2232B76EF64}"/>
              </a:ext>
            </a:extLst>
          </p:cNvPr>
          <p:cNvCxnSpPr>
            <a:cxnSpLocks/>
          </p:cNvCxnSpPr>
          <p:nvPr/>
        </p:nvCxnSpPr>
        <p:spPr>
          <a:xfrm>
            <a:off x="3811588" y="3805658"/>
            <a:ext cx="30212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>
            <a:extLst>
              <a:ext uri="{FF2B5EF4-FFF2-40B4-BE49-F238E27FC236}">
                <a16:creationId xmlns:a16="http://schemas.microsoft.com/office/drawing/2014/main" id="{0A63ECBC-95FF-4D21-ABC4-3F80671C146D}"/>
              </a:ext>
            </a:extLst>
          </p:cNvPr>
          <p:cNvSpPr txBox="1"/>
          <p:nvPr/>
        </p:nvSpPr>
        <p:spPr>
          <a:xfrm>
            <a:off x="4888453" y="3809135"/>
            <a:ext cx="982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NRP2 KO</a:t>
            </a:r>
          </a:p>
        </p:txBody>
      </p: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77D8DF70-07C0-47F2-8B23-516518CB7BF3}"/>
              </a:ext>
            </a:extLst>
          </p:cNvPr>
          <p:cNvCxnSpPr>
            <a:cxnSpLocks/>
          </p:cNvCxnSpPr>
          <p:nvPr/>
        </p:nvCxnSpPr>
        <p:spPr>
          <a:xfrm>
            <a:off x="457467" y="10397512"/>
            <a:ext cx="294732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ZoneTexte 24">
            <a:extLst>
              <a:ext uri="{FF2B5EF4-FFF2-40B4-BE49-F238E27FC236}">
                <a16:creationId xmlns:a16="http://schemas.microsoft.com/office/drawing/2014/main" id="{7E0DC3DB-6F9A-46F9-B9EC-0CDF6981E3A1}"/>
              </a:ext>
            </a:extLst>
          </p:cNvPr>
          <p:cNvSpPr txBox="1"/>
          <p:nvPr/>
        </p:nvSpPr>
        <p:spPr>
          <a:xfrm>
            <a:off x="1382874" y="10400989"/>
            <a:ext cx="9829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NRP1 KO</a:t>
            </a:r>
          </a:p>
        </p:txBody>
      </p: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3AC9979D-3F0F-428B-8E9F-81110AB9F6D7}"/>
              </a:ext>
            </a:extLst>
          </p:cNvPr>
          <p:cNvCxnSpPr>
            <a:cxnSpLocks/>
          </p:cNvCxnSpPr>
          <p:nvPr/>
        </p:nvCxnSpPr>
        <p:spPr>
          <a:xfrm>
            <a:off x="3727451" y="10405233"/>
            <a:ext cx="31054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2DBEDD9E-27BB-4BC9-8A21-60DB3C9124B6}"/>
              </a:ext>
            </a:extLst>
          </p:cNvPr>
          <p:cNvSpPr txBox="1"/>
          <p:nvPr/>
        </p:nvSpPr>
        <p:spPr>
          <a:xfrm>
            <a:off x="4680730" y="10408710"/>
            <a:ext cx="9829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NRP2 KO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6EBE449E-D2F5-4787-BE8F-06ECC682B61C}"/>
              </a:ext>
            </a:extLst>
          </p:cNvPr>
          <p:cNvSpPr txBox="1"/>
          <p:nvPr/>
        </p:nvSpPr>
        <p:spPr>
          <a:xfrm>
            <a:off x="2471966" y="7241615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VEGFC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960A2B0B-3A91-436A-9DF2-496770EA6AD3}"/>
              </a:ext>
            </a:extLst>
          </p:cNvPr>
          <p:cNvSpPr txBox="1"/>
          <p:nvPr/>
        </p:nvSpPr>
        <p:spPr>
          <a:xfrm>
            <a:off x="4170786" y="7273478"/>
            <a:ext cx="7935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VEGFA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896F0FA4-6A8D-4C92-8F9D-F21C89B129F4}"/>
              </a:ext>
            </a:extLst>
          </p:cNvPr>
          <p:cNvSpPr txBox="1"/>
          <p:nvPr/>
        </p:nvSpPr>
        <p:spPr>
          <a:xfrm>
            <a:off x="5814916" y="7236111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VEGFC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7BA09009-835B-491C-A2D4-EF77DC4EAFF2}"/>
              </a:ext>
            </a:extLst>
          </p:cNvPr>
          <p:cNvSpPr txBox="1"/>
          <p:nvPr/>
        </p:nvSpPr>
        <p:spPr>
          <a:xfrm>
            <a:off x="-6412" y="6951679"/>
            <a:ext cx="3513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" name="Graphique 40">
            <a:extLst>
              <a:ext uri="{FF2B5EF4-FFF2-40B4-BE49-F238E27FC236}">
                <a16:creationId xmlns:a16="http://schemas.microsoft.com/office/drawing/2014/main" id="{CF40BE9F-1D84-4247-A6F3-7142962056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1643193"/>
              </p:ext>
            </p:extLst>
          </p:nvPr>
        </p:nvGraphicFramePr>
        <p:xfrm>
          <a:off x="3445777" y="7339492"/>
          <a:ext cx="1746333" cy="29393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2" name="Graphique 41">
            <a:extLst>
              <a:ext uri="{FF2B5EF4-FFF2-40B4-BE49-F238E27FC236}">
                <a16:creationId xmlns:a16="http://schemas.microsoft.com/office/drawing/2014/main" id="{E1F1C45F-BD4D-4915-9BB2-CA2EEA6FEE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7221527"/>
              </p:ext>
            </p:extLst>
          </p:nvPr>
        </p:nvGraphicFramePr>
        <p:xfrm>
          <a:off x="5086530" y="7339492"/>
          <a:ext cx="1746333" cy="29393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3" name="Graphique 42">
            <a:extLst>
              <a:ext uri="{FF2B5EF4-FFF2-40B4-BE49-F238E27FC236}">
                <a16:creationId xmlns:a16="http://schemas.microsoft.com/office/drawing/2014/main" id="{A0800BFE-40FD-4B27-AC27-16CC0A8863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7578866"/>
              </p:ext>
            </p:extLst>
          </p:nvPr>
        </p:nvGraphicFramePr>
        <p:xfrm>
          <a:off x="1839752" y="7335536"/>
          <a:ext cx="1584547" cy="2939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4" name="Graphique 43">
            <a:extLst>
              <a:ext uri="{FF2B5EF4-FFF2-40B4-BE49-F238E27FC236}">
                <a16:creationId xmlns:a16="http://schemas.microsoft.com/office/drawing/2014/main" id="{36FAE071-F854-4844-8DE9-AA86134172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1425311"/>
              </p:ext>
            </p:extLst>
          </p:nvPr>
        </p:nvGraphicFramePr>
        <p:xfrm>
          <a:off x="76314" y="7332324"/>
          <a:ext cx="1796165" cy="2942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4" name="Graphique 33">
            <a:extLst>
              <a:ext uri="{FF2B5EF4-FFF2-40B4-BE49-F238E27FC236}">
                <a16:creationId xmlns:a16="http://schemas.microsoft.com/office/drawing/2014/main" id="{3097C912-C48B-41DF-BB41-DD55C423C6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7086437"/>
              </p:ext>
            </p:extLst>
          </p:nvPr>
        </p:nvGraphicFramePr>
        <p:xfrm>
          <a:off x="297905" y="1228763"/>
          <a:ext cx="1796165" cy="25316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5" name="Graphique 34">
            <a:extLst>
              <a:ext uri="{FF2B5EF4-FFF2-40B4-BE49-F238E27FC236}">
                <a16:creationId xmlns:a16="http://schemas.microsoft.com/office/drawing/2014/main" id="{165EE95B-A985-4E6E-8424-2E890DDEF8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7378706"/>
              </p:ext>
            </p:extLst>
          </p:nvPr>
        </p:nvGraphicFramePr>
        <p:xfrm>
          <a:off x="3599303" y="1228357"/>
          <a:ext cx="1646251" cy="2567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6" name="Graphique 35">
            <a:extLst>
              <a:ext uri="{FF2B5EF4-FFF2-40B4-BE49-F238E27FC236}">
                <a16:creationId xmlns:a16="http://schemas.microsoft.com/office/drawing/2014/main" id="{E20C96EE-9A00-499C-BE01-9F31274B6B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5000676"/>
              </p:ext>
            </p:extLst>
          </p:nvPr>
        </p:nvGraphicFramePr>
        <p:xfrm>
          <a:off x="1977890" y="1233085"/>
          <a:ext cx="1705053" cy="24983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7" name="Graphique 36">
            <a:extLst>
              <a:ext uri="{FF2B5EF4-FFF2-40B4-BE49-F238E27FC236}">
                <a16:creationId xmlns:a16="http://schemas.microsoft.com/office/drawing/2014/main" id="{FF4CEEAC-AE96-4313-B010-B1C4F630BA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9756857"/>
              </p:ext>
            </p:extLst>
          </p:nvPr>
        </p:nvGraphicFramePr>
        <p:xfrm>
          <a:off x="5107716" y="1117533"/>
          <a:ext cx="1734767" cy="2640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8" name="Graphique 37">
            <a:extLst>
              <a:ext uri="{FF2B5EF4-FFF2-40B4-BE49-F238E27FC236}">
                <a16:creationId xmlns:a16="http://schemas.microsoft.com/office/drawing/2014/main" id="{14C66655-FB89-4C27-AD61-2901953BF6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5690989"/>
              </p:ext>
            </p:extLst>
          </p:nvPr>
        </p:nvGraphicFramePr>
        <p:xfrm>
          <a:off x="566278" y="4093477"/>
          <a:ext cx="5519178" cy="2821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CAFA1179-0CA7-48B8-B0BE-14A5730B5399}"/>
              </a:ext>
            </a:extLst>
          </p:cNvPr>
          <p:cNvSpPr txBox="1"/>
          <p:nvPr/>
        </p:nvSpPr>
        <p:spPr>
          <a:xfrm>
            <a:off x="4639079" y="2758591"/>
            <a:ext cx="4828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E30E901B-0F31-4B74-AD5D-5ADE1690625B}"/>
              </a:ext>
            </a:extLst>
          </p:cNvPr>
          <p:cNvSpPr txBox="1"/>
          <p:nvPr/>
        </p:nvSpPr>
        <p:spPr>
          <a:xfrm>
            <a:off x="5646214" y="4679870"/>
            <a:ext cx="5791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A7CE37B0-CA46-40DB-8E6E-DB48146596D2}"/>
              </a:ext>
            </a:extLst>
          </p:cNvPr>
          <p:cNvSpPr txBox="1"/>
          <p:nvPr/>
        </p:nvSpPr>
        <p:spPr>
          <a:xfrm>
            <a:off x="4127224" y="5079980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5" name="Rectangle 20">
            <a:extLst>
              <a:ext uri="{FF2B5EF4-FFF2-40B4-BE49-F238E27FC236}">
                <a16:creationId xmlns:a16="http://schemas.microsoft.com/office/drawing/2014/main" id="{4911BDA9-A962-4D59-AEA4-FE6E4B0FB8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4501" y="648389"/>
            <a:ext cx="420688" cy="188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</a:rPr>
              <a:t>    </a:t>
            </a: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8A8017FC-DED8-4179-9293-E96F31E486C9}"/>
              </a:ext>
            </a:extLst>
          </p:cNvPr>
          <p:cNvSpPr txBox="1"/>
          <p:nvPr/>
        </p:nvSpPr>
        <p:spPr>
          <a:xfrm rot="16200000">
            <a:off x="-1037648" y="5213497"/>
            <a:ext cx="30957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Proliferation (% of control)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BAA60766-D4C7-403D-A95F-AF1319F5B801}"/>
              </a:ext>
            </a:extLst>
          </p:cNvPr>
          <p:cNvSpPr txBox="1"/>
          <p:nvPr/>
        </p:nvSpPr>
        <p:spPr>
          <a:xfrm>
            <a:off x="792403" y="7278982"/>
            <a:ext cx="7935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VEGFA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71A2F168-4212-4FC5-86C1-C504F187B809}"/>
              </a:ext>
            </a:extLst>
          </p:cNvPr>
          <p:cNvSpPr txBox="1"/>
          <p:nvPr/>
        </p:nvSpPr>
        <p:spPr>
          <a:xfrm rot="16200000">
            <a:off x="-1403256" y="8554747"/>
            <a:ext cx="29979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Protein expression (% of control)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B576736F-925A-48AA-AEF2-6464064C8E0D}"/>
              </a:ext>
            </a:extLst>
          </p:cNvPr>
          <p:cNvSpPr txBox="1"/>
          <p:nvPr/>
        </p:nvSpPr>
        <p:spPr>
          <a:xfrm rot="16200000">
            <a:off x="-918307" y="2079693"/>
            <a:ext cx="22987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fr-FR" sz="1800" dirty="0" err="1"/>
              <a:t>Protein</a:t>
            </a:r>
            <a:r>
              <a:rPr lang="fr-FR" sz="1800" baseline="0" dirty="0"/>
              <a:t> expression</a:t>
            </a:r>
          </a:p>
          <a:p>
            <a:pPr algn="ctr" rtl="0"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fr-FR" sz="1800" baseline="0" dirty="0"/>
              <a:t> (% of control)</a:t>
            </a:r>
            <a:endParaRPr lang="en-GB" sz="1800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F1D9020-494B-4476-BFCA-6D9C0FE42820}"/>
              </a:ext>
            </a:extLst>
          </p:cNvPr>
          <p:cNvSpPr txBox="1"/>
          <p:nvPr/>
        </p:nvSpPr>
        <p:spPr>
          <a:xfrm>
            <a:off x="925137" y="1077479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NRP1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57536149-B0CB-4F33-BBCC-F9D654C55DD4}"/>
              </a:ext>
            </a:extLst>
          </p:cNvPr>
          <p:cNvSpPr txBox="1"/>
          <p:nvPr/>
        </p:nvSpPr>
        <p:spPr>
          <a:xfrm>
            <a:off x="2530958" y="1077479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NRP2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16B2C499-F773-4B94-AAF1-EE279AC68653}"/>
              </a:ext>
            </a:extLst>
          </p:cNvPr>
          <p:cNvSpPr txBox="1"/>
          <p:nvPr/>
        </p:nvSpPr>
        <p:spPr>
          <a:xfrm>
            <a:off x="4229439" y="1077479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NRP1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3644C275-3AD0-4562-B509-D80BAC47D1F7}"/>
              </a:ext>
            </a:extLst>
          </p:cNvPr>
          <p:cNvSpPr txBox="1"/>
          <p:nvPr/>
        </p:nvSpPr>
        <p:spPr>
          <a:xfrm>
            <a:off x="5879504" y="1077479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NRP2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8C2B45BD-34E5-4D4C-9852-DD16310E0C30}"/>
              </a:ext>
            </a:extLst>
          </p:cNvPr>
          <p:cNvSpPr txBox="1"/>
          <p:nvPr/>
        </p:nvSpPr>
        <p:spPr>
          <a:xfrm>
            <a:off x="2504147" y="5480090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53A362FD-AC14-4CC5-B04E-06E4AB36A6EF}"/>
              </a:ext>
            </a:extLst>
          </p:cNvPr>
          <p:cNvSpPr txBox="1"/>
          <p:nvPr/>
        </p:nvSpPr>
        <p:spPr>
          <a:xfrm>
            <a:off x="4349290" y="4792162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B52DD60C-7041-44E2-8330-B389F9F6DB8D}"/>
              </a:ext>
            </a:extLst>
          </p:cNvPr>
          <p:cNvSpPr txBox="1"/>
          <p:nvPr/>
        </p:nvSpPr>
        <p:spPr>
          <a:xfrm>
            <a:off x="5899486" y="4525467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840049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74</TotalTime>
  <Words>61</Words>
  <Application>Microsoft Office PowerPoint</Application>
  <PresentationFormat>Grand écran</PresentationFormat>
  <Paragraphs>3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urore Dumond</dc:creator>
  <cp:lastModifiedBy> </cp:lastModifiedBy>
  <cp:revision>38</cp:revision>
  <dcterms:created xsi:type="dcterms:W3CDTF">2020-04-08T08:08:34Z</dcterms:created>
  <dcterms:modified xsi:type="dcterms:W3CDTF">2020-12-10T10:56:19Z</dcterms:modified>
</cp:coreProperties>
</file>